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6" d="100"/>
          <a:sy n="106" d="100"/>
        </p:scale>
        <p:origin x="15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5B1CC5-A046-45C3-A11F-B90F818B88BF}" type="datetimeFigureOut">
              <a:rPr lang="sv-SE" smtClean="0"/>
              <a:t>2016-01-12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38305-E6CB-4FC4-A909-96D8A357799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8331608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5B1CC5-A046-45C3-A11F-B90F818B88BF}" type="datetimeFigureOut">
              <a:rPr lang="sv-SE" smtClean="0"/>
              <a:t>2016-01-12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38305-E6CB-4FC4-A909-96D8A357799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5216795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5B1CC5-A046-45C3-A11F-B90F818B88BF}" type="datetimeFigureOut">
              <a:rPr lang="sv-SE" smtClean="0"/>
              <a:t>2016-01-12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38305-E6CB-4FC4-A909-96D8A357799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3661952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5B1CC5-A046-45C3-A11F-B90F818B88BF}" type="datetimeFigureOut">
              <a:rPr lang="sv-SE" smtClean="0"/>
              <a:t>2016-01-12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38305-E6CB-4FC4-A909-96D8A357799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0909871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5B1CC5-A046-45C3-A11F-B90F818B88BF}" type="datetimeFigureOut">
              <a:rPr lang="sv-SE" smtClean="0"/>
              <a:t>2016-01-12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38305-E6CB-4FC4-A909-96D8A357799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014558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5B1CC5-A046-45C3-A11F-B90F818B88BF}" type="datetimeFigureOut">
              <a:rPr lang="sv-SE" smtClean="0"/>
              <a:t>2016-01-12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38305-E6CB-4FC4-A909-96D8A357799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1843224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5B1CC5-A046-45C3-A11F-B90F818B88BF}" type="datetimeFigureOut">
              <a:rPr lang="sv-SE" smtClean="0"/>
              <a:t>2016-01-12</a:t>
            </a:fld>
            <a:endParaRPr lang="sv-S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38305-E6CB-4FC4-A909-96D8A357799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7918538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5B1CC5-A046-45C3-A11F-B90F818B88BF}" type="datetimeFigureOut">
              <a:rPr lang="sv-SE" smtClean="0"/>
              <a:t>2016-01-12</a:t>
            </a:fld>
            <a:endParaRPr lang="sv-S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38305-E6CB-4FC4-A909-96D8A357799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1098851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5B1CC5-A046-45C3-A11F-B90F818B88BF}" type="datetimeFigureOut">
              <a:rPr lang="sv-SE" smtClean="0"/>
              <a:t>2016-01-12</a:t>
            </a:fld>
            <a:endParaRPr lang="sv-S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38305-E6CB-4FC4-A909-96D8A357799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8742265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5B1CC5-A046-45C3-A11F-B90F818B88BF}" type="datetimeFigureOut">
              <a:rPr lang="sv-SE" smtClean="0"/>
              <a:t>2016-01-12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38305-E6CB-4FC4-A909-96D8A357799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2136094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5B1CC5-A046-45C3-A11F-B90F818B88BF}" type="datetimeFigureOut">
              <a:rPr lang="sv-SE" smtClean="0"/>
              <a:t>2016-01-12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38305-E6CB-4FC4-A909-96D8A357799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67509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5B1CC5-A046-45C3-A11F-B90F818B88BF}" type="datetimeFigureOut">
              <a:rPr lang="sv-SE" smtClean="0"/>
              <a:t>2016-01-12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E38305-E6CB-4FC4-A909-96D8A357799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8884296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962180" y="472765"/>
            <a:ext cx="7286470" cy="5274178"/>
            <a:chOff x="962180" y="771525"/>
            <a:chExt cx="7286470" cy="5274178"/>
          </a:xfrm>
        </p:grpSpPr>
        <p:sp>
          <p:nvSpPr>
            <p:cNvPr id="4" name="TextBox 3"/>
            <p:cNvSpPr txBox="1"/>
            <p:nvPr/>
          </p:nvSpPr>
          <p:spPr>
            <a:xfrm>
              <a:off x="962180" y="771525"/>
              <a:ext cx="26700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b="1" dirty="0" err="1" smtClean="0"/>
                <a:t>Supplementary</a:t>
              </a:r>
              <a:r>
                <a:rPr lang="sv-SE" b="1" dirty="0" smtClean="0"/>
                <a:t> </a:t>
              </a:r>
              <a:r>
                <a:rPr lang="sv-SE" b="1" dirty="0" err="1" smtClean="0"/>
                <a:t>figure</a:t>
              </a:r>
              <a:r>
                <a:rPr lang="sv-SE" b="1" dirty="0" smtClean="0"/>
                <a:t> S1.</a:t>
              </a:r>
              <a:endParaRPr lang="sv-SE" b="1" dirty="0"/>
            </a:p>
          </p:txBody>
        </p:sp>
        <p:grpSp>
          <p:nvGrpSpPr>
            <p:cNvPr id="14" name="Group 13"/>
            <p:cNvGrpSpPr/>
            <p:nvPr/>
          </p:nvGrpSpPr>
          <p:grpSpPr>
            <a:xfrm>
              <a:off x="1481174" y="1782716"/>
              <a:ext cx="6767476" cy="4262987"/>
              <a:chOff x="1481174" y="1782716"/>
              <a:chExt cx="6767476" cy="4262987"/>
            </a:xfrm>
          </p:grpSpPr>
          <p:grpSp>
            <p:nvGrpSpPr>
              <p:cNvPr id="8" name="Group 7"/>
              <p:cNvGrpSpPr/>
              <p:nvPr/>
            </p:nvGrpSpPr>
            <p:grpSpPr>
              <a:xfrm>
                <a:off x="1481174" y="1782716"/>
                <a:ext cx="5951721" cy="4262987"/>
                <a:chOff x="1481174" y="1782716"/>
                <a:chExt cx="5951721" cy="4262987"/>
              </a:xfrm>
            </p:grpSpPr>
            <p:pic>
              <p:nvPicPr>
                <p:cNvPr id="5" name="Picture 4"/>
                <p:cNvPicPr>
                  <a:picLocks noChangeAspect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038133" y="1782716"/>
                  <a:ext cx="5394762" cy="4047543"/>
                </a:xfrm>
                <a:prstGeom prst="rect">
                  <a:avLst/>
                </a:prstGeom>
              </p:spPr>
            </p:pic>
            <p:sp>
              <p:nvSpPr>
                <p:cNvPr id="6" name="TextBox 5"/>
                <p:cNvSpPr txBox="1"/>
                <p:nvPr/>
              </p:nvSpPr>
              <p:spPr>
                <a:xfrm rot="16200000">
                  <a:off x="1007666" y="3307245"/>
                  <a:ext cx="1316347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dirty="0" smtClean="0"/>
                    <a:t>% CO</a:t>
                  </a:r>
                  <a:r>
                    <a:rPr lang="sv-SE" baseline="-25000" dirty="0" smtClean="0"/>
                    <a:t>2 </a:t>
                  </a:r>
                  <a:r>
                    <a:rPr lang="sv-SE" dirty="0" err="1" smtClean="0"/>
                    <a:t>out</a:t>
                  </a:r>
                  <a:endParaRPr lang="sv-SE" baseline="-25000" dirty="0"/>
                </a:p>
              </p:txBody>
            </p:sp>
            <p:sp>
              <p:nvSpPr>
                <p:cNvPr id="7" name="TextBox 6"/>
                <p:cNvSpPr txBox="1"/>
                <p:nvPr/>
              </p:nvSpPr>
              <p:spPr>
                <a:xfrm>
                  <a:off x="4879818" y="5830259"/>
                  <a:ext cx="307818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800" b="1" dirty="0" smtClean="0"/>
                    <a:t>(h)</a:t>
                  </a:r>
                  <a:endParaRPr lang="sv-SE" sz="800" b="1" dirty="0"/>
                </a:p>
              </p:txBody>
            </p:sp>
          </p:grpSp>
          <p:pic>
            <p:nvPicPr>
              <p:cNvPr id="13" name="Picture 12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7519987" y="3294857"/>
                <a:ext cx="728663" cy="788553"/>
              </a:xfrm>
              <a:prstGeom prst="rect">
                <a:avLst/>
              </a:prstGeom>
            </p:spPr>
          </p:pic>
        </p:grpSp>
      </p:grpSp>
      <p:sp>
        <p:nvSpPr>
          <p:cNvPr id="3" name="TextBox 2"/>
          <p:cNvSpPr txBox="1"/>
          <p:nvPr/>
        </p:nvSpPr>
        <p:spPr>
          <a:xfrm>
            <a:off x="1412341" y="5746943"/>
            <a:ext cx="6645243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Supplementary figure S1. </a:t>
            </a:r>
            <a:r>
              <a:rPr lang="en-US" sz="1600" dirty="0"/>
              <a:t>Profiles of CO</a:t>
            </a:r>
            <a:r>
              <a:rPr lang="en-US" sz="1600" baseline="-25000" dirty="0"/>
              <a:t>2</a:t>
            </a:r>
            <a:r>
              <a:rPr lang="en-US" sz="1600" dirty="0"/>
              <a:t> production over time during batch fermentations of the </a:t>
            </a:r>
            <a:r>
              <a:rPr lang="en-US" sz="1600" i="1" dirty="0"/>
              <a:t>HAP1</a:t>
            </a:r>
            <a:r>
              <a:rPr lang="en-US" sz="1600" dirty="0"/>
              <a:t> overexpressing strains (JLM-1 and JLM-2) and the control strain.</a:t>
            </a:r>
            <a:endParaRPr lang="sv-SE" sz="1600" dirty="0"/>
          </a:p>
          <a:p>
            <a:endParaRPr lang="sv-SE" dirty="0"/>
          </a:p>
        </p:txBody>
      </p:sp>
    </p:spTree>
    <p:extLst>
      <p:ext uri="{BB962C8B-B14F-4D97-AF65-F5344CB8AC3E}">
        <p14:creationId xmlns:p14="http://schemas.microsoft.com/office/powerpoint/2010/main" val="28113770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962180" y="391283"/>
            <a:ext cx="7520917" cy="5379410"/>
            <a:chOff x="962180" y="771525"/>
            <a:chExt cx="7520917" cy="5379410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065368" y="1618861"/>
              <a:ext cx="6417729" cy="4532074"/>
            </a:xfrm>
            <a:prstGeom prst="rect">
              <a:avLst/>
            </a:prstGeom>
          </p:spPr>
        </p:pic>
        <p:sp>
          <p:nvSpPr>
            <p:cNvPr id="5" name="TextBox 4"/>
            <p:cNvSpPr txBox="1"/>
            <p:nvPr/>
          </p:nvSpPr>
          <p:spPr>
            <a:xfrm>
              <a:off x="962180" y="771525"/>
              <a:ext cx="26700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b="1" dirty="0" err="1" smtClean="0"/>
                <a:t>Supplementary</a:t>
              </a:r>
              <a:r>
                <a:rPr lang="sv-SE" b="1" dirty="0" smtClean="0"/>
                <a:t> </a:t>
              </a:r>
              <a:r>
                <a:rPr lang="sv-SE" b="1" dirty="0" err="1" smtClean="0"/>
                <a:t>figure</a:t>
              </a:r>
              <a:r>
                <a:rPr lang="sv-SE" b="1" dirty="0" smtClean="0"/>
                <a:t> S2.</a:t>
              </a:r>
              <a:endParaRPr lang="sv-SE" b="1" dirty="0"/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2145671" y="5770693"/>
            <a:ext cx="670861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Supplementary figure S2. </a:t>
            </a:r>
            <a:r>
              <a:rPr lang="en-US" sz="1600" dirty="0"/>
              <a:t>Differences observed in cell volume of the different cell populations studied (JLM-1, JLM-2 and Control) by using flow cytometry.</a:t>
            </a:r>
            <a:endParaRPr lang="sv-SE" sz="1600" dirty="0"/>
          </a:p>
        </p:txBody>
      </p:sp>
    </p:spTree>
    <p:extLst>
      <p:ext uri="{BB962C8B-B14F-4D97-AF65-F5344CB8AC3E}">
        <p14:creationId xmlns:p14="http://schemas.microsoft.com/office/powerpoint/2010/main" val="32011837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69</Words>
  <Application>Microsoft Office PowerPoint</Application>
  <PresentationFormat>Widescreen</PresentationFormat>
  <Paragraphs>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>Chalmer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se Luis Martinez Ruiz</dc:creator>
  <cp:lastModifiedBy>Jose Luis Martinez Ruiz</cp:lastModifiedBy>
  <cp:revision>1</cp:revision>
  <dcterms:created xsi:type="dcterms:W3CDTF">2016-01-12T08:11:18Z</dcterms:created>
  <dcterms:modified xsi:type="dcterms:W3CDTF">2016-01-12T08:14:04Z</dcterms:modified>
</cp:coreProperties>
</file>